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332" y="-48"/>
      </p:cViewPr>
      <p:guideLst>
        <p:guide orient="horz" pos="292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4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image" Target="../media/image2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4535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1762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346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5085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4733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9500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8319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8546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8095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0654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0236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59EE8-1C9D-42EA-9D3C-893CD6D9E61F}" type="datetimeFigureOut">
              <a:rPr lang="de-DE" smtClean="0"/>
              <a:t>04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0420FE-CD0E-40D5-B20B-FF8F1AF7AA2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793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10" Type="http://schemas.openxmlformats.org/officeDocument/2006/relationships/image" Target="../media/image8.emf"/><Relationship Id="rId4" Type="http://schemas.openxmlformats.org/officeDocument/2006/relationships/image" Target="../media/image5.emf"/><Relationship Id="rId9" Type="http://schemas.openxmlformats.org/officeDocument/2006/relationships/oleObject" Target="../embeddings/oleObject8.bin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4.png"/><Relationship Id="rId18" Type="http://schemas.microsoft.com/office/2007/relationships/hdphoto" Target="../media/hdphoto6.wdp"/><Relationship Id="rId26" Type="http://schemas.microsoft.com/office/2007/relationships/hdphoto" Target="../media/hdphoto10.wdp"/><Relationship Id="rId3" Type="http://schemas.openxmlformats.org/officeDocument/2006/relationships/oleObject" Target="../embeddings/oleObject9.bin"/><Relationship Id="rId21" Type="http://schemas.openxmlformats.org/officeDocument/2006/relationships/image" Target="../media/image18.png"/><Relationship Id="rId7" Type="http://schemas.openxmlformats.org/officeDocument/2006/relationships/image" Target="../media/image11.png"/><Relationship Id="rId12" Type="http://schemas.microsoft.com/office/2007/relationships/hdphoto" Target="../media/hdphoto3.wdp"/><Relationship Id="rId17" Type="http://schemas.openxmlformats.org/officeDocument/2006/relationships/image" Target="../media/image16.png"/><Relationship Id="rId25" Type="http://schemas.openxmlformats.org/officeDocument/2006/relationships/image" Target="../media/image20.png"/><Relationship Id="rId2" Type="http://schemas.openxmlformats.org/officeDocument/2006/relationships/slideLayout" Target="../slideLayouts/slideLayout2.xml"/><Relationship Id="rId16" Type="http://schemas.microsoft.com/office/2007/relationships/hdphoto" Target="../media/hdphoto5.wdp"/><Relationship Id="rId20" Type="http://schemas.microsoft.com/office/2007/relationships/hdphoto" Target="../media/hdphoto7.wdp"/><Relationship Id="rId29" Type="http://schemas.openxmlformats.org/officeDocument/2006/relationships/image" Target="../media/image22.png"/><Relationship Id="rId1" Type="http://schemas.openxmlformats.org/officeDocument/2006/relationships/vmlDrawing" Target="../drawings/vmlDrawing3.vml"/><Relationship Id="rId6" Type="http://schemas.openxmlformats.org/officeDocument/2006/relationships/image" Target="../media/image10.emf"/><Relationship Id="rId11" Type="http://schemas.openxmlformats.org/officeDocument/2006/relationships/image" Target="../media/image13.png"/><Relationship Id="rId24" Type="http://schemas.microsoft.com/office/2007/relationships/hdphoto" Target="../media/hdphoto9.wdp"/><Relationship Id="rId5" Type="http://schemas.openxmlformats.org/officeDocument/2006/relationships/oleObject" Target="../embeddings/oleObject10.bin"/><Relationship Id="rId15" Type="http://schemas.openxmlformats.org/officeDocument/2006/relationships/image" Target="../media/image15.png"/><Relationship Id="rId23" Type="http://schemas.openxmlformats.org/officeDocument/2006/relationships/image" Target="../media/image19.png"/><Relationship Id="rId28" Type="http://schemas.microsoft.com/office/2007/relationships/hdphoto" Target="../media/hdphoto11.wdp"/><Relationship Id="rId10" Type="http://schemas.microsoft.com/office/2007/relationships/hdphoto" Target="../media/hdphoto2.wdp"/><Relationship Id="rId19" Type="http://schemas.openxmlformats.org/officeDocument/2006/relationships/image" Target="../media/image17.png"/><Relationship Id="rId4" Type="http://schemas.openxmlformats.org/officeDocument/2006/relationships/image" Target="../media/image9.emf"/><Relationship Id="rId9" Type="http://schemas.openxmlformats.org/officeDocument/2006/relationships/image" Target="../media/image12.png"/><Relationship Id="rId14" Type="http://schemas.microsoft.com/office/2007/relationships/hdphoto" Target="../media/hdphoto4.wdp"/><Relationship Id="rId22" Type="http://schemas.microsoft.com/office/2007/relationships/hdphoto" Target="../media/hdphoto8.wdp"/><Relationship Id="rId27" Type="http://schemas.openxmlformats.org/officeDocument/2006/relationships/image" Target="../media/image21.png"/><Relationship Id="rId30" Type="http://schemas.microsoft.com/office/2007/relationships/hdphoto" Target="../media/hdphoto12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29.png"/><Relationship Id="rId3" Type="http://schemas.openxmlformats.org/officeDocument/2006/relationships/oleObject" Target="../embeddings/oleObject11.bin"/><Relationship Id="rId7" Type="http://schemas.openxmlformats.org/officeDocument/2006/relationships/image" Target="../media/image25.png"/><Relationship Id="rId12" Type="http://schemas.openxmlformats.org/officeDocument/2006/relationships/image" Target="../media/image28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4.emf"/><Relationship Id="rId11" Type="http://schemas.microsoft.com/office/2007/relationships/hdphoto" Target="../media/hdphoto14.wdp"/><Relationship Id="rId5" Type="http://schemas.openxmlformats.org/officeDocument/2006/relationships/oleObject" Target="../embeddings/oleObject12.bin"/><Relationship Id="rId10" Type="http://schemas.openxmlformats.org/officeDocument/2006/relationships/image" Target="../media/image27.png"/><Relationship Id="rId4" Type="http://schemas.openxmlformats.org/officeDocument/2006/relationships/image" Target="../media/image23.emf"/><Relationship Id="rId9" Type="http://schemas.microsoft.com/office/2007/relationships/hdphoto" Target="../media/hdphoto13.wdp"/><Relationship Id="rId1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0636504"/>
              </p:ext>
            </p:extLst>
          </p:nvPr>
        </p:nvGraphicFramePr>
        <p:xfrm>
          <a:off x="333375" y="4716016"/>
          <a:ext cx="3100388" cy="2233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0" name="Prism 7" r:id="rId3" imgW="4297134" imgH="3101069" progId="Prism7.Document">
                  <p:embed/>
                </p:oleObj>
              </mc:Choice>
              <mc:Fallback>
                <p:oleObj name="Prism 7" r:id="rId3" imgW="4297134" imgH="3101069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3375" y="4716016"/>
                        <a:ext cx="3100388" cy="223361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3441108"/>
              </p:ext>
            </p:extLst>
          </p:nvPr>
        </p:nvGraphicFramePr>
        <p:xfrm>
          <a:off x="3632202" y="4719539"/>
          <a:ext cx="3013075" cy="2444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1" name="Prism 7" r:id="rId5" imgW="4183029" imgH="3387599" progId="Prism7.Document">
                  <p:embed/>
                </p:oleObj>
              </mc:Choice>
              <mc:Fallback>
                <p:oleObj name="Prism 7" r:id="rId5" imgW="4183029" imgH="3387599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32202" y="4719539"/>
                        <a:ext cx="3013075" cy="24447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6453630"/>
              </p:ext>
            </p:extLst>
          </p:nvPr>
        </p:nvGraphicFramePr>
        <p:xfrm>
          <a:off x="3571875" y="1741678"/>
          <a:ext cx="3097213" cy="2527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2" name="Prism 7" r:id="rId7" imgW="4338169" imgH="3543102" progId="Prism7.Document">
                  <p:embed/>
                </p:oleObj>
              </mc:Choice>
              <mc:Fallback>
                <p:oleObj name="Prism 7" r:id="rId7" imgW="4338169" imgH="3543102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71875" y="1741678"/>
                        <a:ext cx="3097213" cy="25273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1373481"/>
              </p:ext>
            </p:extLst>
          </p:nvPr>
        </p:nvGraphicFramePr>
        <p:xfrm>
          <a:off x="423863" y="1692275"/>
          <a:ext cx="3078162" cy="245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3" name="Prism 7" r:id="rId9" imgW="4243861" imgH="3395158" progId="Prism7.Document">
                  <p:embed/>
                </p:oleObj>
              </mc:Choice>
              <mc:Fallback>
                <p:oleObj name="Prism 7" r:id="rId9" imgW="4243861" imgH="3395158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3863" y="1692275"/>
                        <a:ext cx="3078162" cy="24574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2564905" y="539552"/>
            <a:ext cx="165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ged C57BL/6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88642" y="375881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ig. S1</a:t>
            </a:r>
            <a:endParaRPr lang="de-DE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052738" y="1327334"/>
            <a:ext cx="15506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T-maze Learning</a:t>
            </a:r>
            <a:endParaRPr lang="de-DE" sz="1600" dirty="0"/>
          </a:p>
        </p:txBody>
      </p:sp>
      <p:sp>
        <p:nvSpPr>
          <p:cNvPr id="12" name="TextBox 11"/>
          <p:cNvSpPr txBox="1"/>
          <p:nvPr/>
        </p:nvSpPr>
        <p:spPr>
          <a:xfrm>
            <a:off x="4365106" y="1327334"/>
            <a:ext cx="16457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Learning (in days)</a:t>
            </a:r>
            <a:endParaRPr lang="de-DE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1227547" y="4375026"/>
            <a:ext cx="11213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Correct (%)</a:t>
            </a:r>
            <a:endParaRPr lang="de-DE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4322301" y="4355976"/>
            <a:ext cx="1843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Delayed Alternation</a:t>
            </a:r>
            <a:endParaRPr lang="de-DE" sz="1600" dirty="0"/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C28B246E-FC65-4196-A079-C3062B85CA44}"/>
              </a:ext>
            </a:extLst>
          </p:cNvPr>
          <p:cNvSpPr txBox="1"/>
          <p:nvPr/>
        </p:nvSpPr>
        <p:spPr>
          <a:xfrm>
            <a:off x="188640" y="117833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+mj-lt"/>
                <a:cs typeface="Arial" panose="020B0604020202020204" pitchFamily="34" charset="0"/>
              </a:rPr>
              <a:t>A</a:t>
            </a:r>
            <a:endParaRPr lang="en-US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C28B246E-FC65-4196-A079-C3062B85CA44}"/>
              </a:ext>
            </a:extLst>
          </p:cNvPr>
          <p:cNvSpPr txBox="1"/>
          <p:nvPr/>
        </p:nvSpPr>
        <p:spPr>
          <a:xfrm>
            <a:off x="3645024" y="117833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+mj-lt"/>
                <a:cs typeface="Arial" panose="020B0604020202020204" pitchFamily="34" charset="0"/>
              </a:rPr>
              <a:t>B</a:t>
            </a:r>
            <a:endParaRPr lang="en-US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C28B246E-FC65-4196-A079-C3062B85CA44}"/>
              </a:ext>
            </a:extLst>
          </p:cNvPr>
          <p:cNvSpPr txBox="1"/>
          <p:nvPr/>
        </p:nvSpPr>
        <p:spPr>
          <a:xfrm>
            <a:off x="3645024" y="421196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+mj-lt"/>
                <a:cs typeface="Arial" panose="020B0604020202020204" pitchFamily="34" charset="0"/>
              </a:rPr>
              <a:t>D</a:t>
            </a:r>
            <a:endParaRPr lang="en-US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C28B246E-FC65-4196-A079-C3062B85CA44}"/>
              </a:ext>
            </a:extLst>
          </p:cNvPr>
          <p:cNvSpPr txBox="1"/>
          <p:nvPr/>
        </p:nvSpPr>
        <p:spPr>
          <a:xfrm>
            <a:off x="208736" y="421196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+mj-lt"/>
                <a:cs typeface="Arial" panose="020B0604020202020204" pitchFamily="34" charset="0"/>
              </a:rPr>
              <a:t>C</a:t>
            </a:r>
            <a:endParaRPr lang="en-US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208736" y="7579494"/>
            <a:ext cx="631660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Figure S1. </a:t>
            </a:r>
            <a:r>
              <a:rPr lang="en-US" sz="1200" b="1" dirty="0"/>
              <a:t>Effects of YKS on behavior of aged </a:t>
            </a:r>
            <a:r>
              <a:rPr lang="en-US" sz="1200" b="1" dirty="0" smtClean="0"/>
              <a:t>mice</a:t>
            </a:r>
            <a:r>
              <a:rPr lang="en-US" sz="1200" b="1" dirty="0"/>
              <a:t>. </a:t>
            </a:r>
            <a:r>
              <a:rPr lang="en-US" sz="1200" dirty="0"/>
              <a:t>T-maze learning </a:t>
            </a:r>
            <a:r>
              <a:rPr lang="en-US" sz="1200" dirty="0" smtClean="0"/>
              <a:t>curves are </a:t>
            </a:r>
            <a:r>
              <a:rPr lang="en-US" sz="1200" dirty="0"/>
              <a:t>represented </a:t>
            </a:r>
            <a:r>
              <a:rPr lang="en-US" sz="1200" dirty="0" smtClean="0"/>
              <a:t>as </a:t>
            </a:r>
            <a:r>
              <a:rPr lang="en-US" sz="1200" dirty="0"/>
              <a:t>% of correct choices during every session; data is shown as mean ± SEM (A). Learning threshold (in days) to reach the criteria of 80% correct choices per a session; individual values and mean ± SEM are shown (B). Correct </a:t>
            </a:r>
            <a:r>
              <a:rPr lang="en-US" sz="1200" dirty="0" smtClean="0"/>
              <a:t>choice: </a:t>
            </a:r>
            <a:r>
              <a:rPr lang="en-US" sz="1200" dirty="0"/>
              <a:t>% of correct choices during Phase I and Phase II; data shown as </a:t>
            </a:r>
            <a:r>
              <a:rPr lang="en-US" sz="1200" dirty="0" smtClean="0"/>
              <a:t>M </a:t>
            </a:r>
            <a:r>
              <a:rPr lang="en-US" sz="1200" dirty="0"/>
              <a:t>(Q1; Q3), min to max </a:t>
            </a:r>
            <a:r>
              <a:rPr lang="en-US" sz="1200" dirty="0" smtClean="0"/>
              <a:t>value (C). </a:t>
            </a:r>
            <a:r>
              <a:rPr lang="en-US" sz="1200" dirty="0"/>
              <a:t>Delayed alternation: % of correct choices after 0, 10, 30, 60 and 120 s </a:t>
            </a:r>
            <a:r>
              <a:rPr lang="en-US" sz="1200" dirty="0" err="1" smtClean="0"/>
              <a:t>intratrial</a:t>
            </a:r>
            <a:r>
              <a:rPr lang="en-US" sz="1200" dirty="0" smtClean="0"/>
              <a:t> </a:t>
            </a:r>
            <a:r>
              <a:rPr lang="en-US" sz="1200" dirty="0"/>
              <a:t>delays during Phase II; data shown as M (Q1;Q3), min to max </a:t>
            </a:r>
            <a:r>
              <a:rPr lang="en-US" sz="1200" dirty="0" smtClean="0"/>
              <a:t>value (D)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954178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9379883"/>
              </p:ext>
            </p:extLst>
          </p:nvPr>
        </p:nvGraphicFramePr>
        <p:xfrm>
          <a:off x="425450" y="4806950"/>
          <a:ext cx="2749550" cy="2081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4" name="Prism 7" r:id="rId3" imgW="4205706" imgH="3093510" progId="Prism7.Document">
                  <p:embed/>
                </p:oleObj>
              </mc:Choice>
              <mc:Fallback>
                <p:oleObj name="Prism 7" r:id="rId3" imgW="4205706" imgH="3093510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5450" y="4806950"/>
                        <a:ext cx="2749550" cy="2081213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2739549"/>
              </p:ext>
            </p:extLst>
          </p:nvPr>
        </p:nvGraphicFramePr>
        <p:xfrm>
          <a:off x="3525838" y="4783138"/>
          <a:ext cx="2974975" cy="2327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5" name="Prism 7" r:id="rId5" imgW="4266538" imgH="3234975" progId="Prism7.Document">
                  <p:embed/>
                </p:oleObj>
              </mc:Choice>
              <mc:Fallback>
                <p:oleObj name="Prism 7" r:id="rId5" imgW="4266538" imgH="3234975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25838" y="4783138"/>
                        <a:ext cx="2974975" cy="2327275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9370559"/>
              </p:ext>
            </p:extLst>
          </p:nvPr>
        </p:nvGraphicFramePr>
        <p:xfrm>
          <a:off x="3816350" y="1657350"/>
          <a:ext cx="2762250" cy="1997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6" name="Prism 7" r:id="rId7" imgW="4292455" imgH="3009639" progId="Prism7.Document">
                  <p:embed/>
                </p:oleObj>
              </mc:Choice>
              <mc:Fallback>
                <p:oleObj name="Prism 7" r:id="rId7" imgW="4292455" imgH="3009639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16350" y="1657350"/>
                        <a:ext cx="2762250" cy="1997075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2181558"/>
              </p:ext>
            </p:extLst>
          </p:nvPr>
        </p:nvGraphicFramePr>
        <p:xfrm>
          <a:off x="547688" y="1695450"/>
          <a:ext cx="2808287" cy="2152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7" name="Prism 7" r:id="rId9" imgW="4207146" imgH="3123747" progId="Prism7.Document">
                  <p:embed/>
                </p:oleObj>
              </mc:Choice>
              <mc:Fallback>
                <p:oleObj name="Prism 7" r:id="rId9" imgW="4207146" imgH="3123747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7688" y="1695450"/>
                        <a:ext cx="2808287" cy="2152650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017281" y="467544"/>
            <a:ext cx="822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x FA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4625" y="107504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ig. S2</a:t>
            </a:r>
            <a:endParaRPr lang="de-DE" b="1" dirty="0"/>
          </a:p>
        </p:txBody>
      </p:sp>
      <p:sp>
        <p:nvSpPr>
          <p:cNvPr id="2" name="TextBox 1"/>
          <p:cNvSpPr txBox="1"/>
          <p:nvPr/>
        </p:nvSpPr>
        <p:spPr>
          <a:xfrm>
            <a:off x="1124745" y="1327334"/>
            <a:ext cx="15506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T-maze Learning</a:t>
            </a:r>
            <a:endParaRPr lang="de-DE" sz="1600" dirty="0"/>
          </a:p>
        </p:txBody>
      </p:sp>
      <p:sp>
        <p:nvSpPr>
          <p:cNvPr id="12" name="TextBox 11"/>
          <p:cNvSpPr txBox="1"/>
          <p:nvPr/>
        </p:nvSpPr>
        <p:spPr>
          <a:xfrm>
            <a:off x="4542681" y="1327334"/>
            <a:ext cx="16457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Learning (in days)</a:t>
            </a:r>
            <a:endParaRPr lang="de-DE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1227547" y="4301148"/>
            <a:ext cx="11213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Correct (%)</a:t>
            </a:r>
            <a:endParaRPr lang="de-DE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4077074" y="4229140"/>
            <a:ext cx="1843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Delayed Alternation</a:t>
            </a:r>
            <a:endParaRPr lang="de-DE" sz="1600" dirty="0"/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C28B246E-FC65-4196-A079-C3062B85CA44}"/>
              </a:ext>
            </a:extLst>
          </p:cNvPr>
          <p:cNvSpPr txBox="1"/>
          <p:nvPr/>
        </p:nvSpPr>
        <p:spPr>
          <a:xfrm>
            <a:off x="188640" y="117833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+mj-lt"/>
                <a:cs typeface="Arial" panose="020B0604020202020204" pitchFamily="34" charset="0"/>
              </a:rPr>
              <a:t>A</a:t>
            </a:r>
            <a:endParaRPr lang="en-US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C28B246E-FC65-4196-A079-C3062B85CA44}"/>
              </a:ext>
            </a:extLst>
          </p:cNvPr>
          <p:cNvSpPr txBox="1"/>
          <p:nvPr/>
        </p:nvSpPr>
        <p:spPr>
          <a:xfrm>
            <a:off x="208736" y="392392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+mj-lt"/>
                <a:cs typeface="Arial" panose="020B0604020202020204" pitchFamily="34" charset="0"/>
              </a:rPr>
              <a:t>C</a:t>
            </a:r>
            <a:endParaRPr lang="en-US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C28B246E-FC65-4196-A079-C3062B85CA44}"/>
              </a:ext>
            </a:extLst>
          </p:cNvPr>
          <p:cNvSpPr txBox="1"/>
          <p:nvPr/>
        </p:nvSpPr>
        <p:spPr>
          <a:xfrm>
            <a:off x="3645024" y="117833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+mj-lt"/>
                <a:cs typeface="Arial" panose="020B0604020202020204" pitchFamily="34" charset="0"/>
              </a:rPr>
              <a:t>B</a:t>
            </a:r>
            <a:endParaRPr lang="en-US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C28B246E-FC65-4196-A079-C3062B85CA44}"/>
              </a:ext>
            </a:extLst>
          </p:cNvPr>
          <p:cNvSpPr txBox="1"/>
          <p:nvPr/>
        </p:nvSpPr>
        <p:spPr>
          <a:xfrm>
            <a:off x="3645024" y="3923928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+mj-lt"/>
                <a:cs typeface="Arial" panose="020B0604020202020204" pitchFamily="34" charset="0"/>
              </a:rPr>
              <a:t>D</a:t>
            </a:r>
            <a:endParaRPr lang="en-US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208736" y="7579494"/>
            <a:ext cx="631660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Figure S2</a:t>
            </a:r>
            <a:r>
              <a:rPr lang="en-US" sz="1200" b="1" dirty="0"/>
              <a:t>.</a:t>
            </a:r>
            <a:r>
              <a:rPr lang="en-US" sz="1200" b="1" dirty="0" smtClean="0"/>
              <a:t> </a:t>
            </a:r>
            <a:r>
              <a:rPr lang="en-US" sz="1200" b="1" dirty="0"/>
              <a:t>Effects of YKS on behavior </a:t>
            </a:r>
            <a:r>
              <a:rPr lang="en-US" sz="1200" b="1" dirty="0" smtClean="0"/>
              <a:t>of </a:t>
            </a:r>
            <a:r>
              <a:rPr lang="en-US" sz="1200" b="1" dirty="0"/>
              <a:t>5x FAD mice. </a:t>
            </a:r>
            <a:r>
              <a:rPr lang="en-US" sz="1200" dirty="0"/>
              <a:t>T-maze learning </a:t>
            </a:r>
            <a:r>
              <a:rPr lang="en-US" sz="1200" dirty="0" smtClean="0"/>
              <a:t>curves are </a:t>
            </a:r>
            <a:r>
              <a:rPr lang="en-US" sz="1200" dirty="0"/>
              <a:t>represented </a:t>
            </a:r>
            <a:r>
              <a:rPr lang="en-US" sz="1200" dirty="0" smtClean="0"/>
              <a:t>as </a:t>
            </a:r>
            <a:r>
              <a:rPr lang="en-US" sz="1200" dirty="0"/>
              <a:t>% of correct choices during every session; data is shown as mean ± SEM (A). Learning threshold (in days) to reach the criteria of 80% correct choices per a session; individual values and mean ± SEM are shown (B). Correct </a:t>
            </a:r>
            <a:r>
              <a:rPr lang="en-US" sz="1200" dirty="0" smtClean="0"/>
              <a:t>choice: </a:t>
            </a:r>
            <a:r>
              <a:rPr lang="en-US" sz="1200" dirty="0"/>
              <a:t>% of correct choices during Phase I and Phase II; data shown as M (Q1; Q3), min to max </a:t>
            </a:r>
            <a:r>
              <a:rPr lang="en-US" sz="1200" dirty="0" smtClean="0"/>
              <a:t>value (C). </a:t>
            </a:r>
            <a:r>
              <a:rPr lang="en-US" sz="1200" dirty="0"/>
              <a:t>Delayed alternation: % of correct choices after 0, 10, 30, 60 and 120 s </a:t>
            </a:r>
            <a:r>
              <a:rPr lang="en-US" sz="1200" dirty="0" err="1"/>
              <a:t>intratrial</a:t>
            </a:r>
            <a:r>
              <a:rPr lang="en-US" sz="1200" dirty="0"/>
              <a:t> delays during Phase II; data shown as M (Q1;Q3), min to max </a:t>
            </a:r>
            <a:r>
              <a:rPr lang="en-US" sz="1200" dirty="0" smtClean="0"/>
              <a:t>value (D)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3067074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5956116"/>
              </p:ext>
            </p:extLst>
          </p:nvPr>
        </p:nvGraphicFramePr>
        <p:xfrm>
          <a:off x="4846638" y="1211263"/>
          <a:ext cx="1343025" cy="2176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6" name="Prism 7" r:id="rId3" imgW="3021816" imgH="5236002" progId="Prism7.Document">
                  <p:embed/>
                </p:oleObj>
              </mc:Choice>
              <mc:Fallback>
                <p:oleObj name="Prism 7" r:id="rId3" imgW="3021816" imgH="5236002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46638" y="1211263"/>
                        <a:ext cx="1343025" cy="2176462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1134819"/>
              </p:ext>
            </p:extLst>
          </p:nvPr>
        </p:nvGraphicFramePr>
        <p:xfrm>
          <a:off x="4833938" y="4156075"/>
          <a:ext cx="1387475" cy="2190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7" name="Prism 7" r:id="rId5" imgW="3038374" imgH="5455218" progId="Prism7.Document">
                  <p:embed/>
                </p:oleObj>
              </mc:Choice>
              <mc:Fallback>
                <p:oleObj name="Prism 7" r:id="rId5" imgW="3038374" imgH="5455218" progId="Prism7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33938" y="4156075"/>
                        <a:ext cx="1387475" cy="2190750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8" descr="U:\Rahul\Backup_DZNE computer\Alexander Lab\Projects\Yokukansan\Data\Rahul Data\Analysis\Analysis with Macros\Iba_1\Representative images\FAD_IBa-1 intensity\4937_CA1_Image43_composite.png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5120" y="1145557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10" descr="U:\Rahul\Backup_DZNE computer\Alexander Lab\Projects\Yokukansan\Data\Rahul Data\Analysis\Analysis with Macros\Iba_1\Representative images\FAD_IBa-1 intensity\C1-4937_CA1_Image43.tif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233" y="1153794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1" descr="U:\Rahul\Backup_DZNE computer\Alexander Lab\Projects\Yokukansan\Data\Rahul Data\Analysis\Analysis with Macros\Iba_1\Representative images\FAD_IBa-1 intensity\C3-4937_CA1_Image43.tif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7164" y="1153794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5" descr="U:\Rahul\Backup_DZNE computer\Alexander Lab\Projects\Yokukansan\Data\Rahul Data\Analysis\Analysis with Macros\Iba_1\Representative images\FAD_IBa-1 intensity\4936_CA1_Image11_composite.png"/>
          <p:cNvPicPr preferRelativeResize="0">
            <a:picLocks noChangeArrowheads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5120" y="2249871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6" descr="U:\Rahul\Backup_DZNE computer\Alexander Lab\Projects\Yokukansan\Data\Rahul Data\Analysis\Analysis with Macros\Iba_1\Representative images\FAD_IBa-1 intensity\C1-4936_CA1_Image11.tif"/>
          <p:cNvPicPr preferRelativeResize="0">
            <a:picLocks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232" y="2249871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7" descr="U:\Rahul\Backup_DZNE computer\Alexander Lab\Projects\Yokukansan\Data\Rahul Data\Analysis\Analysis with Macros\Iba_1\Representative images\FAD_IBa-1 intensity\C3-4936_CA1_Image11.tif"/>
          <p:cNvPicPr preferRelativeResize="0">
            <a:picLocks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7164" y="2249871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0" descr="U:\Rahul\Backup_DZNE computer\Alexander Lab\Projects\Yokukansan\Data\Rahul Data\Analysis\Analysis with Macros\Iba_1\Representative images\FAD_IBa-1 intensity\CA3\4937_CA3_Image37_composite.png"/>
          <p:cNvPicPr preferRelativeResize="0">
            <a:picLocks noChangeArrowheads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3675" y="4038956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21" descr="U:\Rahul\Backup_DZNE computer\Alexander Lab\Projects\Yokukansan\Data\Rahul Data\Analysis\Analysis with Macros\Iba_1\Representative images\FAD_IBa-1 intensity\CA3\4938_CA3_Image14_composite.png"/>
          <p:cNvPicPr preferRelativeResize="0">
            <a:picLocks noChangeArrowheads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3675" y="5120485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2" descr="U:\Rahul\Backup_DZNE computer\Alexander Lab\Projects\Yokukansan\Data\Rahul Data\Analysis\Analysis with Macros\Iba_1\Representative images\FAD_IBa-1 intensity\CA3\C1-4937_CA3_Image37.tif"/>
          <p:cNvPicPr preferRelativeResize="0">
            <a:picLocks noChangeArrowheads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105" y="4038956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23" descr="U:\Rahul\Backup_DZNE computer\Alexander Lab\Projects\Yokukansan\Data\Rahul Data\Analysis\Analysis with Macros\Iba_1\Representative images\FAD_IBa-1 intensity\CA3\C1-4938_CA3_Image14.tif"/>
          <p:cNvPicPr preferRelativeResize="0">
            <a:picLocks noChangeArrowheads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105" y="5120485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24" descr="U:\Rahul\Backup_DZNE computer\Alexander Lab\Projects\Yokukansan\Data\Rahul Data\Analysis\Analysis with Macros\Iba_1\Representative images\FAD_IBa-1 intensity\CA3\C3-4937_CA3_Image37.tif"/>
          <p:cNvPicPr preferRelativeResize="0">
            <a:picLocks noChangeArrowheads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7283" y="4038956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25" descr="U:\Rahul\Backup_DZNE computer\Alexander Lab\Projects\Yokukansan\Data\Rahul Data\Analysis\Analysis with Macros\Iba_1\Representative images\FAD_IBa-1 intensity\CA3\C3-4938_CA3_Image14.tif"/>
          <p:cNvPicPr preferRelativeResize="0">
            <a:picLocks noChangeArrowheads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7164" y="5120485"/>
            <a:ext cx="1134000" cy="1046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/>
          <p:cNvSpPr txBox="1"/>
          <p:nvPr/>
        </p:nvSpPr>
        <p:spPr>
          <a:xfrm rot="16200000">
            <a:off x="573805" y="1560031"/>
            <a:ext cx="659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/>
              <a:t>Control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675069" y="2633629"/>
            <a:ext cx="420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YKS</a:t>
            </a:r>
            <a:endParaRPr lang="de-DE" sz="1200" b="1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570084" y="4407658"/>
            <a:ext cx="659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/>
              <a:t>Control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697166" y="5534033"/>
            <a:ext cx="420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YKS</a:t>
            </a:r>
            <a:endParaRPr lang="de-DE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71034" y="78327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76672" y="3641435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C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805814" y="3641435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D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509120" y="786947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B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515856" y="920553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CA1</a:t>
            </a:r>
            <a:endParaRPr lang="de-DE" sz="12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57326" y="384458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</a:t>
            </a:r>
            <a:r>
              <a:rPr lang="en-US" b="1" dirty="0" smtClean="0"/>
              <a:t>S3</a:t>
            </a:r>
            <a:endParaRPr lang="de-DE" dirty="0"/>
          </a:p>
        </p:txBody>
      </p:sp>
      <p:sp>
        <p:nvSpPr>
          <p:cNvPr id="2" name="Rectangle 1"/>
          <p:cNvSpPr/>
          <p:nvPr/>
        </p:nvSpPr>
        <p:spPr>
          <a:xfrm>
            <a:off x="260648" y="7031351"/>
            <a:ext cx="62646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Figure S3. </a:t>
            </a:r>
            <a:r>
              <a:rPr lang="en-US" sz="1200" b="1" dirty="0"/>
              <a:t>Effects of YKS on microglial activation in 5xFAD mice</a:t>
            </a:r>
            <a:r>
              <a:rPr lang="en-US" sz="1200" dirty="0"/>
              <a:t>. </a:t>
            </a:r>
            <a:r>
              <a:rPr lang="en-US" sz="1200" dirty="0" smtClean="0"/>
              <a:t>Intensities </a:t>
            </a:r>
            <a:r>
              <a:rPr lang="en-US" sz="1200" dirty="0"/>
              <a:t>of IBA1 </a:t>
            </a:r>
            <a:r>
              <a:rPr lang="en-US" sz="1200" dirty="0" smtClean="0"/>
              <a:t>were normalized to the </a:t>
            </a:r>
            <a:r>
              <a:rPr lang="en-US" sz="1200" dirty="0"/>
              <a:t>control slices </a:t>
            </a:r>
            <a:r>
              <a:rPr lang="en-US" sz="1200" dirty="0" smtClean="0"/>
              <a:t>for </a:t>
            </a:r>
            <a:r>
              <a:rPr lang="en-US" sz="1200" dirty="0"/>
              <a:t>CA1 </a:t>
            </a:r>
            <a:r>
              <a:rPr lang="en-US" sz="1200" dirty="0" smtClean="0"/>
              <a:t>(A</a:t>
            </a:r>
            <a:r>
              <a:rPr lang="en-US" sz="1200" dirty="0"/>
              <a:t>) and CA3 (C) areas of </a:t>
            </a:r>
            <a:r>
              <a:rPr lang="en-US" sz="1200" dirty="0" smtClean="0"/>
              <a:t>the hippocampus.  </a:t>
            </a:r>
            <a:r>
              <a:rPr lang="en-US" sz="1200" dirty="0"/>
              <a:t>Panels B and D show the quantification. Bar graph represents mean </a:t>
            </a:r>
            <a:r>
              <a:rPr lang="en-US" sz="1200" dirty="0"/>
              <a:t>± </a:t>
            </a:r>
            <a:r>
              <a:rPr lang="en-US" sz="1200" dirty="0"/>
              <a:t>SEM values.</a:t>
            </a:r>
            <a:endParaRPr lang="de-DE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2492896" y="3795380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CA3</a:t>
            </a:r>
            <a:endParaRPr lang="de-DE" sz="12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1030964" y="1152075"/>
            <a:ext cx="495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DAPI</a:t>
            </a:r>
            <a:endParaRPr lang="de-DE" sz="1200" b="1" dirty="0">
              <a:solidFill>
                <a:schemeClr val="bg1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153960" y="1141789"/>
            <a:ext cx="482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IBA1</a:t>
            </a:r>
            <a:endParaRPr lang="de-DE" sz="1200" b="1" dirty="0">
              <a:solidFill>
                <a:schemeClr val="bg1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339888" y="1140745"/>
            <a:ext cx="597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Merge</a:t>
            </a:r>
            <a:endParaRPr lang="de-DE" sz="1200" b="1" dirty="0">
              <a:solidFill>
                <a:schemeClr val="bg1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041850" y="4050434"/>
            <a:ext cx="495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DAPI</a:t>
            </a:r>
            <a:endParaRPr lang="de-DE" sz="1200" b="1" dirty="0">
              <a:solidFill>
                <a:schemeClr val="bg1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164846" y="4040147"/>
            <a:ext cx="482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IBA1</a:t>
            </a:r>
            <a:endParaRPr lang="de-DE" sz="1200" b="1" dirty="0">
              <a:solidFill>
                <a:schemeClr val="bg1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350774" y="4039103"/>
            <a:ext cx="5979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Merge</a:t>
            </a:r>
            <a:endParaRPr lang="de-DE" sz="1200" b="1" dirty="0">
              <a:solidFill>
                <a:schemeClr val="bg1"/>
              </a:solidFill>
            </a:endParaRPr>
          </a:p>
        </p:txBody>
      </p:sp>
      <p:grpSp>
        <p:nvGrpSpPr>
          <p:cNvPr id="36" name="Group 35"/>
          <p:cNvGrpSpPr>
            <a:grpSpLocks noChangeAspect="1"/>
          </p:cNvGrpSpPr>
          <p:nvPr/>
        </p:nvGrpSpPr>
        <p:grpSpPr>
          <a:xfrm>
            <a:off x="5589234" y="899592"/>
            <a:ext cx="551244" cy="342635"/>
            <a:chOff x="5717500" y="5803901"/>
            <a:chExt cx="968034" cy="601700"/>
          </a:xfrm>
        </p:grpSpPr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xmlns="" id="{A1E77D97-A4C9-4066-B73F-BB92B1796CBF}"/>
                </a:ext>
              </a:extLst>
            </p:cNvPr>
            <p:cNvSpPr/>
            <p:nvPr/>
          </p:nvSpPr>
          <p:spPr>
            <a:xfrm>
              <a:off x="5717500" y="5905661"/>
              <a:ext cx="176881" cy="160801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+mj-lt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6482B423-E3B1-4022-A3B2-1F9B8B217925}"/>
                </a:ext>
              </a:extLst>
            </p:cNvPr>
            <p:cNvSpPr txBox="1"/>
            <p:nvPr/>
          </p:nvSpPr>
          <p:spPr>
            <a:xfrm>
              <a:off x="5815130" y="5803901"/>
              <a:ext cx="870404" cy="3783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cs typeface="Arial" panose="020B0604020202020204" pitchFamily="34" charset="0"/>
                </a:rPr>
                <a:t>Control</a:t>
              </a:r>
              <a:endParaRPr 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xmlns="" id="{BD0A9A87-72EF-4559-A762-25F281480C71}"/>
                </a:ext>
              </a:extLst>
            </p:cNvPr>
            <p:cNvSpPr/>
            <p:nvPr/>
          </p:nvSpPr>
          <p:spPr>
            <a:xfrm>
              <a:off x="5717500" y="6130368"/>
              <a:ext cx="176881" cy="160801"/>
            </a:xfrm>
            <a:prstGeom prst="rect">
              <a:avLst/>
            </a:prstGeom>
            <a:solidFill>
              <a:srgbClr val="66FF99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+mj-lt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D5671694-1A2E-4187-AB20-1AB43EE37F37}"/>
                </a:ext>
              </a:extLst>
            </p:cNvPr>
            <p:cNvSpPr txBox="1"/>
            <p:nvPr/>
          </p:nvSpPr>
          <p:spPr>
            <a:xfrm>
              <a:off x="5826739" y="6031043"/>
              <a:ext cx="680553" cy="3745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+mj-lt"/>
                </a:rPr>
                <a:t>YKS</a:t>
              </a:r>
              <a:endParaRPr lang="en-US" sz="800" dirty="0">
                <a:latin typeface="+mj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599163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4626" y="128464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Fig. </a:t>
            </a:r>
            <a:r>
              <a:rPr lang="de-DE" b="1" dirty="0" smtClean="0"/>
              <a:t>S4</a:t>
            </a:r>
            <a:endParaRPr lang="en-US" b="1" dirty="0" smtClean="0"/>
          </a:p>
        </p:txBody>
      </p:sp>
      <p:grpSp>
        <p:nvGrpSpPr>
          <p:cNvPr id="24" name="Group 23"/>
          <p:cNvGrpSpPr>
            <a:grpSpLocks noChangeAspect="1"/>
          </p:cNvGrpSpPr>
          <p:nvPr/>
        </p:nvGrpSpPr>
        <p:grpSpPr>
          <a:xfrm>
            <a:off x="787400" y="2325688"/>
            <a:ext cx="3287714" cy="1908175"/>
            <a:chOff x="829759" y="1524060"/>
            <a:chExt cx="3067355" cy="1780276"/>
          </a:xfrm>
        </p:grpSpPr>
        <p:graphicFrame>
          <p:nvGraphicFramePr>
            <p:cNvPr id="25" name="Object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23467740"/>
                </p:ext>
              </p:extLst>
            </p:nvPr>
          </p:nvGraphicFramePr>
          <p:xfrm>
            <a:off x="829759" y="1524060"/>
            <a:ext cx="1633652" cy="178027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52" name="Prism 7" r:id="rId3" imgW="5115310" imgH="5566446" progId="Prism7.Document">
                    <p:embed/>
                  </p:oleObj>
                </mc:Choice>
                <mc:Fallback>
                  <p:oleObj name="Prism 7" r:id="rId3" imgW="5115310" imgH="5566446" progId="Prism7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829759" y="1524060"/>
                          <a:ext cx="1633652" cy="1780276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6" name="Object 2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38425509"/>
                </p:ext>
              </p:extLst>
            </p:nvPr>
          </p:nvGraphicFramePr>
          <p:xfrm>
            <a:off x="2307895" y="1549238"/>
            <a:ext cx="1589219" cy="171807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53" name="Prism 7" r:id="rId5" imgW="4905097" imgH="5302955" progId="Prism7.Document">
                    <p:embed/>
                  </p:oleObj>
                </mc:Choice>
                <mc:Fallback>
                  <p:oleObj name="Prism 7" r:id="rId5" imgW="4905097" imgH="5302955" progId="Prism7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307895" y="1549238"/>
                          <a:ext cx="1589219" cy="171807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7" name="TextBox 26"/>
          <p:cNvSpPr txBox="1"/>
          <p:nvPr/>
        </p:nvSpPr>
        <p:spPr>
          <a:xfrm>
            <a:off x="399026" y="63252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A</a:t>
            </a:r>
            <a:endParaRPr lang="en-US" sz="14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451984" y="218942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B</a:t>
            </a:r>
            <a:endParaRPr lang="en-US" sz="14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2324192" y="2189422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C</a:t>
            </a:r>
            <a:endParaRPr lang="en-US" sz="1400" b="1" dirty="0"/>
          </a:p>
        </p:txBody>
      </p:sp>
      <p:pic>
        <p:nvPicPr>
          <p:cNvPr id="35" name="Picture 8" descr="V:\Rahul\Backup_DZNE computer\Alexander Lab\Projects\Yokukansan\Data\Rahul Data\Analysis\Analysis with Macros\A-Beta analysis\Representative images\C1-Image55_5x_CA1-1_Dapi_selection.png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4996" y="916623"/>
            <a:ext cx="1080000" cy="9969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9" descr="V:\Rahul\Backup_DZNE computer\Alexander Lab\Projects\Yokukansan\Data\Rahul Data\Analysis\Analysis with Macros\A-Beta analysis\Representative images\C1-Image55_5x_CA1_Aß_threshold selection.png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3599" y="916320"/>
            <a:ext cx="1080000" cy="9969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11" descr="V:\Rahul\Backup_DZNE computer\Alexander Lab\Projects\Yokukansan\Data\Rahul Data\Analysis\Analysis with Macros\A-Beta analysis\Representative images\C1-Image55_5x_CA1_dapi_threshold selection.png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8027" y="916623"/>
            <a:ext cx="1080000" cy="9969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99" descr="V:\Rahul\Backup_DZNE computer\Alexander Lab\Projects\Yokukansan\Data\Rahul Data\Analysis\Analysis with Macros\A-Beta analysis\Representative images\C1-Image55_5x_CA1-1_Dapi_selection-zoom.tif"/>
          <p:cNvPicPr preferRelativeResize="0">
            <a:picLocks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52" t="5990" r="4313" b="8888"/>
          <a:stretch/>
        </p:blipFill>
        <p:spPr bwMode="auto">
          <a:xfrm>
            <a:off x="5301264" y="1444954"/>
            <a:ext cx="504000" cy="465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331468" y="4501733"/>
            <a:ext cx="64099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Figure S4. </a:t>
            </a:r>
            <a:r>
              <a:rPr lang="en-US" sz="1200" b="1" dirty="0"/>
              <a:t>Effects of YKS on </a:t>
            </a:r>
            <a:r>
              <a:rPr lang="en-US" sz="1200" b="1" dirty="0" err="1"/>
              <a:t>Aß</a:t>
            </a:r>
            <a:r>
              <a:rPr lang="en-US" sz="1200" b="1" dirty="0"/>
              <a:t>-plaques </a:t>
            </a:r>
            <a:r>
              <a:rPr lang="en-US" sz="1200" b="1" dirty="0" smtClean="0"/>
              <a:t>load. </a:t>
            </a:r>
            <a:r>
              <a:rPr lang="en-US" sz="1200" dirty="0" smtClean="0"/>
              <a:t>(A) Immunostaining </a:t>
            </a:r>
            <a:r>
              <a:rPr lang="en-US" sz="1200" dirty="0"/>
              <a:t>with </a:t>
            </a:r>
            <a:r>
              <a:rPr lang="en-US" sz="1200" dirty="0" err="1"/>
              <a:t>Aß</a:t>
            </a:r>
            <a:r>
              <a:rPr lang="en-US" sz="1200" dirty="0"/>
              <a:t>-antibody and DAPI counterstaining were used to quantify the total plaque area and the total number of plaques, </a:t>
            </a:r>
            <a:r>
              <a:rPr lang="en-US" sz="1200" dirty="0" smtClean="0"/>
              <a:t>respectively. </a:t>
            </a:r>
            <a:r>
              <a:rPr lang="en-US" sz="1200" dirty="0"/>
              <a:t>(B, </a:t>
            </a:r>
            <a:r>
              <a:rPr lang="en-US" sz="1200" dirty="0" smtClean="0"/>
              <a:t>C) </a:t>
            </a:r>
            <a:r>
              <a:rPr lang="en-US" sz="1200" dirty="0"/>
              <a:t>Bar graphs represent the respective </a:t>
            </a:r>
            <a:r>
              <a:rPr lang="en-US" sz="1200" dirty="0" smtClean="0"/>
              <a:t>quantification. </a:t>
            </a:r>
            <a:endParaRPr lang="de-DE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1887832" y="871120"/>
            <a:ext cx="495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DAPI</a:t>
            </a:r>
            <a:endParaRPr lang="de-DE" sz="1200" b="1" dirty="0">
              <a:solidFill>
                <a:schemeClr val="bg1"/>
              </a:solidFill>
            </a:endParaRPr>
          </a:p>
        </p:txBody>
      </p:sp>
      <p:pic>
        <p:nvPicPr>
          <p:cNvPr id="24651" name="Picture 75" descr="V:\Rahul\Dityatev's lab on Network drive\Projects_network drive\Yokukansan\Data\Rahul Data\Analysis\Analysis with Macros\A-Beta analysis\Representative images\C2-Image55_5x_CA1-1_scale.pn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7832" y="916320"/>
            <a:ext cx="1080000" cy="9969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TextBox 48"/>
          <p:cNvSpPr txBox="1"/>
          <p:nvPr/>
        </p:nvSpPr>
        <p:spPr>
          <a:xfrm>
            <a:off x="746590" y="860834"/>
            <a:ext cx="6577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</a:rPr>
              <a:t>anti-Aß</a:t>
            </a:r>
            <a:endParaRPr lang="de-DE" sz="1200" b="1" dirty="0">
              <a:solidFill>
                <a:schemeClr val="bg1"/>
              </a:solidFill>
            </a:endParaRPr>
          </a:p>
        </p:txBody>
      </p:sp>
      <p:pic>
        <p:nvPicPr>
          <p:cNvPr id="24652" name="Picture 76" descr="V:\Rahul\Dityatev's lab on Network drive\Projects_network drive\Yokukansan\Data\Rahul Data\Analysis\Analysis with Macros\A-Beta analysis\Representative images\C2-Image55_5x_CA1-1_zoom_scale.png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1264" y="919681"/>
            <a:ext cx="504000" cy="465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8" name="Group 17"/>
          <p:cNvGrpSpPr>
            <a:grpSpLocks noChangeAspect="1"/>
          </p:cNvGrpSpPr>
          <p:nvPr/>
        </p:nvGrpSpPr>
        <p:grpSpPr>
          <a:xfrm>
            <a:off x="3765379" y="2343310"/>
            <a:ext cx="551244" cy="342635"/>
            <a:chOff x="5717500" y="5803901"/>
            <a:chExt cx="968034" cy="601700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xmlns="" id="{A1E77D97-A4C9-4066-B73F-BB92B1796CBF}"/>
                </a:ext>
              </a:extLst>
            </p:cNvPr>
            <p:cNvSpPr/>
            <p:nvPr/>
          </p:nvSpPr>
          <p:spPr>
            <a:xfrm>
              <a:off x="5717500" y="5905661"/>
              <a:ext cx="176881" cy="160801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+mj-lt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6482B423-E3B1-4022-A3B2-1F9B8B217925}"/>
                </a:ext>
              </a:extLst>
            </p:cNvPr>
            <p:cNvSpPr txBox="1"/>
            <p:nvPr/>
          </p:nvSpPr>
          <p:spPr>
            <a:xfrm>
              <a:off x="5815130" y="5803901"/>
              <a:ext cx="870404" cy="3783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cs typeface="Arial" panose="020B0604020202020204" pitchFamily="34" charset="0"/>
                </a:rPr>
                <a:t>Control</a:t>
              </a:r>
              <a:endParaRPr 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xmlns="" id="{BD0A9A87-72EF-4559-A762-25F281480C71}"/>
                </a:ext>
              </a:extLst>
            </p:cNvPr>
            <p:cNvSpPr/>
            <p:nvPr/>
          </p:nvSpPr>
          <p:spPr>
            <a:xfrm>
              <a:off x="5717500" y="6130368"/>
              <a:ext cx="176881" cy="160801"/>
            </a:xfrm>
            <a:prstGeom prst="rect">
              <a:avLst/>
            </a:prstGeom>
            <a:solidFill>
              <a:srgbClr val="66FF99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latin typeface="+mj-lt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D5671694-1A2E-4187-AB20-1AB43EE37F37}"/>
                </a:ext>
              </a:extLst>
            </p:cNvPr>
            <p:cNvSpPr txBox="1"/>
            <p:nvPr/>
          </p:nvSpPr>
          <p:spPr>
            <a:xfrm>
              <a:off x="5826739" y="6031043"/>
              <a:ext cx="680553" cy="3745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+mj-lt"/>
                </a:rPr>
                <a:t>YKS</a:t>
              </a:r>
              <a:endParaRPr lang="en-US" sz="800" dirty="0">
                <a:latin typeface="+mj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545322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1</Words>
  <Application>Microsoft Office PowerPoint</Application>
  <PresentationFormat>On-screen Show (4:3)</PresentationFormat>
  <Paragraphs>51</Paragraphs>
  <Slides>4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hul Kaushik</dc:creator>
  <cp:lastModifiedBy>dityateva</cp:lastModifiedBy>
  <cp:revision>20</cp:revision>
  <dcterms:created xsi:type="dcterms:W3CDTF">2018-04-06T12:17:44Z</dcterms:created>
  <dcterms:modified xsi:type="dcterms:W3CDTF">2018-12-04T14:03:16Z</dcterms:modified>
</cp:coreProperties>
</file>